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60" r:id="rId2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3" d="100"/>
          <a:sy n="93" d="100"/>
        </p:scale>
        <p:origin x="462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40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39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1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9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0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7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2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19DE-B8FD-48B2-8070-ACBE374E5355}" type="datetimeFigureOut">
              <a:rPr lang="en-US" smtClean="0"/>
              <a:t>12/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5B8C347F-F9F0-3BCE-0DB8-121EC3E271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2ED4D015-1A9F-BD35-FE60-2CBFFF9F4F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268" y="3574341"/>
            <a:ext cx="6099464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ure 3.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ot blot analysis demonstrating the binding of </a:t>
            </a:r>
            <a:r>
              <a:rPr kumimoji="0" lang="en-US" alt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B8 to different forms of CA I. (1) native CA I (5 </a:t>
            </a:r>
            <a:r>
              <a:rPr kumimoji="0" lang="el-GR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), (2) CA I unfolded by </a:t>
            </a:r>
            <a:r>
              <a:rPr kumimoji="0" lang="en-US" alt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iGest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reated with DTT and IAA (5 </a:t>
            </a:r>
            <a:r>
              <a:rPr kumimoji="0" lang="el-GR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), (3) unfolded CA I digested by TPCK-trypsin (5 </a:t>
            </a:r>
            <a:r>
              <a:rPr kumimoji="0" lang="el-GR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), (4) BSA (5 </a:t>
            </a:r>
            <a:r>
              <a:rPr kumimoji="0" lang="el-GR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), (5) 10 mM phosphate buffer pH 7.0; dilution: 1,000x; dilution of secondary HRP-conjugated antibody: 1,000x; colorimetric detection: Opti-4CN </a:t>
            </a: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t.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Skupina 6">
            <a:extLst>
              <a:ext uri="{FF2B5EF4-FFF2-40B4-BE49-F238E27FC236}">
                <a16:creationId xmlns:a16="http://schemas.microsoft.com/office/drawing/2014/main" id="{72B36682-4D4A-1FF8-A805-83DAB2C0BEC0}"/>
              </a:ext>
            </a:extLst>
          </p:cNvPr>
          <p:cNvGrpSpPr/>
          <p:nvPr/>
        </p:nvGrpSpPr>
        <p:grpSpPr>
          <a:xfrm>
            <a:off x="570058" y="1266213"/>
            <a:ext cx="5717883" cy="1499114"/>
            <a:chOff x="438293" y="1700808"/>
            <a:chExt cx="5717883" cy="1499114"/>
          </a:xfrm>
        </p:grpSpPr>
        <p:pic>
          <p:nvPicPr>
            <p:cNvPr id="3" name="Picture 11">
              <a:extLst>
                <a:ext uri="{FF2B5EF4-FFF2-40B4-BE49-F238E27FC236}">
                  <a16:creationId xmlns:a16="http://schemas.microsoft.com/office/drawing/2014/main" id="{C393B0C5-4D7D-D607-890F-985DEF2F983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59" t="66542" r="7572" b="22560"/>
            <a:stretch/>
          </p:blipFill>
          <p:spPr bwMode="auto">
            <a:xfrm rot="16200000">
              <a:off x="1529575" y="2026605"/>
              <a:ext cx="1207146" cy="11316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>
              <a:extLst>
                <a:ext uri="{FF2B5EF4-FFF2-40B4-BE49-F238E27FC236}">
                  <a16:creationId xmlns:a16="http://schemas.microsoft.com/office/drawing/2014/main" id="{F70350CE-0312-1229-625D-705B9C26882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40" t="55349" r="21838" b="30586"/>
            <a:stretch/>
          </p:blipFill>
          <p:spPr bwMode="auto">
            <a:xfrm>
              <a:off x="2698956" y="1992776"/>
              <a:ext cx="1137468" cy="1203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12">
              <a:extLst>
                <a:ext uri="{FF2B5EF4-FFF2-40B4-BE49-F238E27FC236}">
                  <a16:creationId xmlns:a16="http://schemas.microsoft.com/office/drawing/2014/main" id="{147733B3-257B-6F58-68E9-08B54A3E247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49" t="3981" r="26830" b="81908"/>
            <a:stretch/>
          </p:blipFill>
          <p:spPr bwMode="auto">
            <a:xfrm>
              <a:off x="438293" y="1988839"/>
              <a:ext cx="1137448" cy="1207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11">
              <a:extLst>
                <a:ext uri="{FF2B5EF4-FFF2-40B4-BE49-F238E27FC236}">
                  <a16:creationId xmlns:a16="http://schemas.microsoft.com/office/drawing/2014/main" id="{CA3F80B1-1F14-FE47-97C2-80BB8DEE070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38" t="87450" r="8093" b="1652"/>
            <a:stretch/>
          </p:blipFill>
          <p:spPr bwMode="auto">
            <a:xfrm rot="16200000">
              <a:off x="4930275" y="2026604"/>
              <a:ext cx="1207146" cy="11316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11">
              <a:extLst>
                <a:ext uri="{FF2B5EF4-FFF2-40B4-BE49-F238E27FC236}">
                  <a16:creationId xmlns:a16="http://schemas.microsoft.com/office/drawing/2014/main" id="{966B53D5-754E-8BB5-A742-36A2CCD4CCF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79" t="88030" r="59652" b="1072"/>
            <a:stretch/>
          </p:blipFill>
          <p:spPr bwMode="auto">
            <a:xfrm rot="16200000">
              <a:off x="3798659" y="2030541"/>
              <a:ext cx="1207146" cy="11316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Obdélník 38">
              <a:extLst>
                <a:ext uri="{FF2B5EF4-FFF2-40B4-BE49-F238E27FC236}">
                  <a16:creationId xmlns:a16="http://schemas.microsoft.com/office/drawing/2014/main" id="{D1B40220-CED2-B348-F8C2-A892C811B1D1}"/>
                </a:ext>
              </a:extLst>
            </p:cNvPr>
            <p:cNvSpPr/>
            <p:nvPr/>
          </p:nvSpPr>
          <p:spPr>
            <a:xfrm>
              <a:off x="438293" y="1992777"/>
              <a:ext cx="5661363" cy="1203208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cxnSp>
          <p:nvCxnSpPr>
            <p:cNvPr id="11" name="Přímá spojnice 54">
              <a:extLst>
                <a:ext uri="{FF2B5EF4-FFF2-40B4-BE49-F238E27FC236}">
                  <a16:creationId xmlns:a16="http://schemas.microsoft.com/office/drawing/2014/main" id="{87A0FE66-0BBA-2460-1260-465912E739A4}"/>
                </a:ext>
              </a:extLst>
            </p:cNvPr>
            <p:cNvCxnSpPr/>
            <p:nvPr/>
          </p:nvCxnSpPr>
          <p:spPr>
            <a:xfrm>
              <a:off x="1567340" y="1992858"/>
              <a:ext cx="8401" cy="1203127"/>
            </a:xfrm>
            <a:prstGeom prst="line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12" name="Přímá spojnice 55">
              <a:extLst>
                <a:ext uri="{FF2B5EF4-FFF2-40B4-BE49-F238E27FC236}">
                  <a16:creationId xmlns:a16="http://schemas.microsoft.com/office/drawing/2014/main" id="{C1CFAF6B-8E74-CCF4-3420-66D609F1EBCD}"/>
                </a:ext>
              </a:extLst>
            </p:cNvPr>
            <p:cNvCxnSpPr/>
            <p:nvPr/>
          </p:nvCxnSpPr>
          <p:spPr>
            <a:xfrm>
              <a:off x="2698956" y="1992858"/>
              <a:ext cx="0" cy="1203127"/>
            </a:xfrm>
            <a:prstGeom prst="line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13" name="Přímá spojnice 56">
              <a:extLst>
                <a:ext uri="{FF2B5EF4-FFF2-40B4-BE49-F238E27FC236}">
                  <a16:creationId xmlns:a16="http://schemas.microsoft.com/office/drawing/2014/main" id="{33D21E94-67A1-10E6-A6F4-748844641A1A}"/>
                </a:ext>
              </a:extLst>
            </p:cNvPr>
            <p:cNvCxnSpPr/>
            <p:nvPr/>
          </p:nvCxnSpPr>
          <p:spPr>
            <a:xfrm>
              <a:off x="3842322" y="1992858"/>
              <a:ext cx="0" cy="1203127"/>
            </a:xfrm>
            <a:prstGeom prst="line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14" name="Přímá spojnice 57">
              <a:extLst>
                <a:ext uri="{FF2B5EF4-FFF2-40B4-BE49-F238E27FC236}">
                  <a16:creationId xmlns:a16="http://schemas.microsoft.com/office/drawing/2014/main" id="{C273B2BA-E9F7-1E88-967A-63453427D756}"/>
                </a:ext>
              </a:extLst>
            </p:cNvPr>
            <p:cNvCxnSpPr/>
            <p:nvPr/>
          </p:nvCxnSpPr>
          <p:spPr>
            <a:xfrm>
              <a:off x="4968040" y="1988839"/>
              <a:ext cx="0" cy="1207146"/>
            </a:xfrm>
            <a:prstGeom prst="line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15" name="TextovéPole 50">
              <a:extLst>
                <a:ext uri="{FF2B5EF4-FFF2-40B4-BE49-F238E27FC236}">
                  <a16:creationId xmlns:a16="http://schemas.microsoft.com/office/drawing/2014/main" id="{7A600888-1128-A091-69D0-BB4CD1C5BF2E}"/>
                </a:ext>
              </a:extLst>
            </p:cNvPr>
            <p:cNvSpPr txBox="1"/>
            <p:nvPr/>
          </p:nvSpPr>
          <p:spPr>
            <a:xfrm>
              <a:off x="665810" y="1700808"/>
              <a:ext cx="54903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cs-CZ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                         2                           3                         4                         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3708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64</TotalTime>
  <Words>108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do Skultety</dc:creator>
  <cp:lastModifiedBy>Ludovit Skultety</cp:lastModifiedBy>
  <cp:revision>21</cp:revision>
  <dcterms:created xsi:type="dcterms:W3CDTF">2023-04-23T08:26:50Z</dcterms:created>
  <dcterms:modified xsi:type="dcterms:W3CDTF">2024-12-06T16:18:03Z</dcterms:modified>
</cp:coreProperties>
</file>